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77" r:id="rId2"/>
    <p:sldId id="259" r:id="rId3"/>
    <p:sldId id="257" r:id="rId4"/>
    <p:sldId id="25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883" autoAdjust="0"/>
    <p:restoredTop sz="87204" autoAdjust="0"/>
  </p:normalViewPr>
  <p:slideViewPr>
    <p:cSldViewPr snapToGrid="0">
      <p:cViewPr varScale="1">
        <p:scale>
          <a:sx n="95" d="100"/>
          <a:sy n="95" d="100"/>
        </p:scale>
        <p:origin x="106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7E7DA2-822D-4886-BF2E-5D81317AA0D2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CCFDA1-33C3-4DBE-A6F2-C11AFA6B48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29275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Google Shape;147;p1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8" name="Google Shape;148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27959568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299C8F-6C0F-4780-81A9-4F0A1AA6E15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47D727D-E7FE-4785-B2CF-63D6263BC58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4BE936-189E-4BE9-B955-E41B96A42B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E9B0E-2A71-47EC-ACBF-08CD4EE58872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CDFA00-9B62-49F6-9CA6-217560E158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D64D06-C73E-4D68-8E34-88DB5F7A4B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F8A74-69FE-478B-BDBB-44AF2795A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8303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CC8DE6-58AB-428A-B87D-27795C4EDC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BE1DE01-8202-4B0E-8AE3-8C7BCDADAE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520107-6459-4C20-BCDC-274671D5ED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E9B0E-2A71-47EC-ACBF-08CD4EE58872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A3AC17-219C-4175-916C-619521C68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43BAED-3E61-4F78-AA53-D0BA215A89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F8A74-69FE-478B-BDBB-44AF2795A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549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41167DE-1D6A-4744-9748-CD5A4795A9B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62BC776-DBA6-46D4-84B0-6F4D0A5414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4F76FE-5C6D-44F5-8CB2-4E50B0EBB8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E9B0E-2A71-47EC-ACBF-08CD4EE58872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EDB2D1-3016-44A5-BF9D-22DBE4F9BE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A712B7-9702-49C9-943D-7E6F5539E9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F8A74-69FE-478B-BDBB-44AF2795A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8747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5C1230-E669-462E-B88D-D3426A99B0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B3121C-25C8-4136-ABDF-DF8373AE8D2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7DE15E-7927-4A2B-89CB-BF8AAFDEEC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E9B0E-2A71-47EC-ACBF-08CD4EE58872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8879AB-E166-4590-A6C7-7EE6898C8E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484CBC-7539-42B7-8CDB-EA56EF2ACB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F8A74-69FE-478B-BDBB-44AF2795A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382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85768C-8388-42E1-BD89-FA968DBB49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9ED445-35D7-4583-9435-48F2198AE2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EB38DD-81AA-42C5-9A54-CE0110EF61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E9B0E-2A71-47EC-ACBF-08CD4EE58872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3AEBA6-3875-43BF-9858-E2076D733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89719D-A93D-4AE2-B793-AC0A26A063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F8A74-69FE-478B-BDBB-44AF2795A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64015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F0BFB5-6560-4F23-B10F-A2DC709C11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5A86D8-6AC3-4E4E-A1A5-E033F1FF225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79343F-F09E-4565-B81E-24115B93A4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BCB6EF-48CB-409B-AC5A-F6ED5514BD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E9B0E-2A71-47EC-ACBF-08CD4EE58872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852716-63FC-423A-B23E-18A50E4B9F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2BF6E1-F885-4905-8E7F-1E02131D69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F8A74-69FE-478B-BDBB-44AF2795A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698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261BA5-F286-4086-9901-52AB38F824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E45617-89E0-439F-ABF4-5218064F51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3157C3A-66C9-4F7E-ADE2-7C25A843CD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B5A4256-2297-413A-B686-E904136426D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24A91D0-E2A0-4035-ACC0-01C6E796382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A235557-47C7-4E0D-B7DB-D42D8BA842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E9B0E-2A71-47EC-ACBF-08CD4EE58872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DAFB200-CD36-4521-A4E5-BB27103C05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CDAF293-EF7B-4A30-9A01-3359B5A868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F8A74-69FE-478B-BDBB-44AF2795A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4650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0E1EF6-ADAD-478A-A2AF-93B84A6FEA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DC0A983-0E12-4ADA-BC6D-F762BB0CF5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E9B0E-2A71-47EC-ACBF-08CD4EE58872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51F0923-622B-49D5-BB65-7EEA5BD19E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AB9ABD5-AD03-46BC-A222-AF2B1D0342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F8A74-69FE-478B-BDBB-44AF2795A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367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F5F4D7F-BFDB-4BA5-8A2E-7B829054B8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E9B0E-2A71-47EC-ACBF-08CD4EE58872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3214AB8-C837-428F-A869-14FF8CFB99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419A0B4-2584-4C48-84E1-D277707A28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F8A74-69FE-478B-BDBB-44AF2795A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3484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5893B0-8A7C-41E5-B95D-9C06447FF6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2F1BC3-C022-4C32-BF15-02C398268CB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567301E-8793-46D9-9501-3E453771A7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30A9F76-C222-44A4-93ED-025529EE90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E9B0E-2A71-47EC-ACBF-08CD4EE58872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58DCE3-5249-40E3-BCA0-CB2E3E6642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313EE6-E199-4B92-AE9D-7B7C4FF945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F8A74-69FE-478B-BDBB-44AF2795A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23974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0E1EE7-72D4-4192-ABAC-B550DADEA2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03FF485-894A-4D86-90CD-0F3C967A947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90703E-460A-4817-899E-B502E29A7E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35FF7B-DDF0-4CCA-998C-A8C18D4C61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E9B0E-2A71-47EC-ACBF-08CD4EE58872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FAD0C6-5DB7-4D45-8F83-9B9CB7813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06A548-3280-420C-A763-7563361566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F8A74-69FE-478B-BDBB-44AF2795A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2983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659D580-2766-4E0D-89CB-5C7DF200F8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983696-F779-45B5-9300-E8F323DA7D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63FFDC-CEAA-4C60-92E9-B5C0EA8AC8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FE9B0E-2A71-47EC-ACBF-08CD4EE58872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4E830E-67A1-48C7-9D3B-4B4CB34DFB2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69003C-A2C5-4298-9D02-A864293D979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FF8A74-69FE-478B-BDBB-44AF2795A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20298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FA7C10F-4F65-49BE-AD88-5A363FBC137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300864" y="573934"/>
            <a:ext cx="7536263" cy="496152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4888732-1B44-4F33-92C9-297CC016030F}"/>
              </a:ext>
            </a:extLst>
          </p:cNvPr>
          <p:cNvSpPr txBox="1"/>
          <p:nvPr/>
        </p:nvSpPr>
        <p:spPr>
          <a:xfrm>
            <a:off x="1922951" y="5657671"/>
            <a:ext cx="9078424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chemeClr val="dk1"/>
                </a:solidFill>
                <a:latin typeface="Cambria"/>
                <a:ea typeface="Cambria"/>
                <a:cs typeface="Cambria"/>
                <a:sym typeface="Cambria"/>
              </a:rPr>
              <a:t>Supplemental Figure S1</a:t>
            </a:r>
            <a:r>
              <a:rPr lang="en-US" dirty="0">
                <a:solidFill>
                  <a:schemeClr val="dk1"/>
                </a:solidFill>
                <a:latin typeface="Cambria"/>
                <a:ea typeface="Cambria"/>
                <a:cs typeface="Cambria"/>
                <a:sym typeface="Cambria"/>
              </a:rPr>
              <a:t>: Manhattan plot for showing </a:t>
            </a:r>
            <a:r>
              <a:rPr lang="en-US" altLang="ja-JP" dirty="0">
                <a:solidFill>
                  <a:schemeClr val="dk1"/>
                </a:solidFill>
                <a:latin typeface="Cambria"/>
                <a:ea typeface="Cambria"/>
                <a:cs typeface="Cambria"/>
                <a:sym typeface="Cambria"/>
              </a:rPr>
              <a:t>suggestive</a:t>
            </a:r>
            <a:r>
              <a:rPr lang="en-US" dirty="0">
                <a:solidFill>
                  <a:schemeClr val="dk1"/>
                </a:solidFill>
                <a:latin typeface="Cambria"/>
                <a:ea typeface="Cambria"/>
                <a:cs typeface="Cambria"/>
                <a:sym typeface="Cambria"/>
              </a:rPr>
              <a:t> association of SNPs with SNE1.  The green dot </a:t>
            </a:r>
            <a:r>
              <a:rPr lang="en-US" altLang="ja-JP" dirty="0">
                <a:solidFill>
                  <a:schemeClr val="dk1"/>
                </a:solidFill>
                <a:latin typeface="Cambria"/>
                <a:ea typeface="Cambria"/>
                <a:cs typeface="Cambria"/>
                <a:sym typeface="Cambria"/>
              </a:rPr>
              <a:t>on chromosome 14 </a:t>
            </a:r>
            <a:r>
              <a:rPr lang="en-US" dirty="0">
                <a:solidFill>
                  <a:schemeClr val="dk1"/>
                </a:solidFill>
                <a:latin typeface="Cambria"/>
                <a:ea typeface="Cambria"/>
                <a:cs typeface="Cambria"/>
                <a:sym typeface="Cambria"/>
              </a:rPr>
              <a:t>represents the suggestive association where – log (</a:t>
            </a:r>
            <a:r>
              <a:rPr lang="en-US" altLang="ja-JP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p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value is less than 5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5812860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86937CA6-0F16-4193-9CD0-CFD2E81D0F5A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5A40B47-FD03-4BED-8706-0822E399EB18}"/>
              </a:ext>
            </a:extLst>
          </p:cNvPr>
          <p:cNvSpPr txBox="1"/>
          <p:nvPr/>
        </p:nvSpPr>
        <p:spPr>
          <a:xfrm>
            <a:off x="642939" y="5473777"/>
            <a:ext cx="11077496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800" b="1" dirty="0">
                <a:latin typeface="Cambria"/>
                <a:ea typeface="Cambria"/>
                <a:cs typeface="Cambria"/>
                <a:sym typeface="Cambria"/>
              </a:rPr>
              <a:t>Supplemental Figure S2</a:t>
            </a:r>
            <a:r>
              <a:rPr lang="en-US" sz="1800" dirty="0">
                <a:latin typeface="Cambria"/>
                <a:ea typeface="Cambria"/>
                <a:cs typeface="Cambria"/>
                <a:sym typeface="Cambria"/>
              </a:rPr>
              <a:t>: Correlations between relative expression of candidate genes and </a:t>
            </a:r>
            <a:r>
              <a:rPr lang="en-US" sz="1800" i="1" dirty="0">
                <a:latin typeface="Cambria"/>
                <a:ea typeface="Cambria"/>
                <a:cs typeface="Cambria"/>
                <a:sym typeface="Cambria"/>
              </a:rPr>
              <a:t>A</a:t>
            </a:r>
            <a:r>
              <a:rPr lang="en-US" sz="1800" i="1" baseline="-25000" dirty="0">
                <a:latin typeface="Cambria"/>
                <a:ea typeface="Cambria"/>
                <a:cs typeface="Cambria"/>
                <a:sym typeface="Cambria"/>
              </a:rPr>
              <a:t>sat</a:t>
            </a:r>
            <a:r>
              <a:rPr lang="en-US" sz="1800" dirty="0">
                <a:latin typeface="Cambria"/>
                <a:ea typeface="Cambria"/>
                <a:cs typeface="Cambria"/>
                <a:sym typeface="Cambria"/>
              </a:rPr>
              <a:t>. Panels show scatter plot of </a:t>
            </a:r>
            <a:r>
              <a:rPr lang="en-US" sz="1800" i="1" dirty="0">
                <a:latin typeface="Cambria"/>
                <a:ea typeface="Cambria"/>
                <a:cs typeface="Cambria"/>
                <a:sym typeface="Cambria"/>
              </a:rPr>
              <a:t>A</a:t>
            </a:r>
            <a:r>
              <a:rPr lang="en-US" sz="1800" i="1" baseline="-25000" dirty="0">
                <a:latin typeface="Cambria"/>
                <a:ea typeface="Cambria"/>
                <a:cs typeface="Cambria"/>
                <a:sym typeface="Cambria"/>
              </a:rPr>
              <a:t>sat</a:t>
            </a:r>
            <a:r>
              <a:rPr lang="en-US" sz="1800" dirty="0">
                <a:latin typeface="Cambria"/>
                <a:ea typeface="Cambria"/>
                <a:cs typeface="Cambria"/>
                <a:sym typeface="Cambria"/>
              </a:rPr>
              <a:t> and the relative expression of Glyma.17G226100 </a:t>
            </a:r>
            <a:r>
              <a:rPr lang="en-US" altLang="ja-JP" sz="1800" b="1" dirty="0">
                <a:latin typeface="Cambria"/>
                <a:ea typeface="Cambria"/>
                <a:cs typeface="Cambria"/>
                <a:sym typeface="Cambria"/>
              </a:rPr>
              <a:t>(A)</a:t>
            </a:r>
            <a:r>
              <a:rPr lang="en-US" sz="1800" dirty="0">
                <a:latin typeface="Cambria"/>
                <a:ea typeface="Cambria"/>
                <a:cs typeface="Cambria"/>
                <a:sym typeface="Cambria"/>
              </a:rPr>
              <a:t>, Glyma.17G226700</a:t>
            </a:r>
            <a:r>
              <a:rPr lang="en-US" altLang="ja-JP" sz="1800" dirty="0">
                <a:latin typeface="Cambria"/>
                <a:ea typeface="Cambria"/>
                <a:cs typeface="Cambria"/>
                <a:sym typeface="Cambria"/>
              </a:rPr>
              <a:t> </a:t>
            </a:r>
            <a:r>
              <a:rPr lang="en-US" altLang="ja-JP" sz="1800" b="1" dirty="0">
                <a:latin typeface="Cambria"/>
                <a:ea typeface="Cambria"/>
                <a:cs typeface="Cambria"/>
                <a:sym typeface="Cambria"/>
              </a:rPr>
              <a:t>(B)</a:t>
            </a:r>
            <a:r>
              <a:rPr lang="en-US" sz="1800" dirty="0">
                <a:latin typeface="Cambria"/>
                <a:ea typeface="Cambria"/>
                <a:cs typeface="Cambria"/>
                <a:sym typeface="Cambria"/>
              </a:rPr>
              <a:t>, and Glyma.17G226900</a:t>
            </a:r>
            <a:r>
              <a:rPr lang="en-US" altLang="ja-JP" sz="1800" dirty="0">
                <a:latin typeface="Cambria"/>
                <a:ea typeface="Cambria"/>
                <a:cs typeface="Cambria"/>
                <a:sym typeface="Cambria"/>
              </a:rPr>
              <a:t> </a:t>
            </a:r>
            <a:r>
              <a:rPr lang="en-US" altLang="ja-JP" sz="1800" b="1" dirty="0">
                <a:latin typeface="Cambria"/>
                <a:ea typeface="Cambria"/>
                <a:cs typeface="Cambria"/>
                <a:sym typeface="Cambria"/>
              </a:rPr>
              <a:t>(C)</a:t>
            </a:r>
            <a:r>
              <a:rPr lang="en-US" sz="1800" dirty="0">
                <a:latin typeface="Cambria"/>
                <a:ea typeface="Cambria"/>
                <a:cs typeface="Cambria"/>
                <a:sym typeface="Cambria"/>
              </a:rPr>
              <a:t>.  Shaded areas show 95% confidence interval. Boxes inside the plots show correlation </a:t>
            </a:r>
            <a:r>
              <a:rPr lang="en-US" altLang="ja-JP" dirty="0">
                <a:latin typeface="Cambria"/>
                <a:ea typeface="Cambria"/>
                <a:cs typeface="Cambria"/>
                <a:sym typeface="Cambria"/>
              </a:rPr>
              <a:t>coefficient</a:t>
            </a:r>
            <a:r>
              <a:rPr lang="en-US" sz="1800" dirty="0">
                <a:latin typeface="Cambria"/>
                <a:ea typeface="Cambria"/>
                <a:cs typeface="Cambria"/>
                <a:sym typeface="Cambria"/>
              </a:rPr>
              <a:t>. </a:t>
            </a:r>
            <a:r>
              <a:rPr lang="en-US" altLang="ja-JP" dirty="0">
                <a:latin typeface="Times New Roman" panose="02020603050405020304" pitchFamily="18" charset="0"/>
                <a:ea typeface="Cambria"/>
                <a:cs typeface="Times New Roman" panose="02020603050405020304" pitchFamily="18" charset="0"/>
                <a:sym typeface="Cambria"/>
              </a:rPr>
              <a:t>**</a:t>
            </a:r>
            <a:r>
              <a:rPr lang="en-US" sz="1800" i="1" dirty="0">
                <a:latin typeface="Times New Roman" panose="02020603050405020304" pitchFamily="18" charset="0"/>
                <a:ea typeface="Cambria"/>
                <a:cs typeface="Times New Roman" panose="02020603050405020304" pitchFamily="18" charset="0"/>
                <a:sym typeface="Cambria"/>
              </a:rPr>
              <a:t>p</a:t>
            </a:r>
            <a:r>
              <a:rPr lang="en-US" sz="1800" dirty="0">
                <a:latin typeface="Times New Roman" panose="02020603050405020304" pitchFamily="18" charset="0"/>
                <a:ea typeface="Cambria"/>
                <a:cs typeface="Times New Roman" panose="02020603050405020304" pitchFamily="18" charset="0"/>
                <a:sym typeface="Cambria"/>
              </a:rPr>
              <a:t> &lt; 0.01.</a:t>
            </a:r>
            <a:endParaRPr lang="en-US" sz="1800" dirty="0">
              <a:latin typeface="Cambria"/>
              <a:ea typeface="Cambria"/>
              <a:cs typeface="Cambria"/>
              <a:sym typeface="Cambria"/>
            </a:endParaRPr>
          </a:p>
        </p:txBody>
      </p:sp>
      <p:pic>
        <p:nvPicPr>
          <p:cNvPr id="10" name="Picture 9" descr="Chart, scatter chart&#10;&#10;Description automatically generated">
            <a:extLst>
              <a:ext uri="{FF2B5EF4-FFF2-40B4-BE49-F238E27FC236}">
                <a16:creationId xmlns:a16="http://schemas.microsoft.com/office/drawing/2014/main" id="{35C15D35-9273-4995-B4D9-94C17D929E8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13" t="3907" r="9335"/>
          <a:stretch/>
        </p:blipFill>
        <p:spPr>
          <a:xfrm>
            <a:off x="1128712" y="1743074"/>
            <a:ext cx="9801225" cy="35147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15291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9EFF38E-EA34-4C6E-B7AF-754849045DD1}"/>
              </a:ext>
            </a:extLst>
          </p:cNvPr>
          <p:cNvSpPr txBox="1"/>
          <p:nvPr/>
        </p:nvSpPr>
        <p:spPr>
          <a:xfrm>
            <a:off x="14735" y="2573456"/>
            <a:ext cx="5350672" cy="15595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ure S3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: Phenotypic variations in biochemical parameters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A)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800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hl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sz="1800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hl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b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and </a:t>
            </a:r>
            <a:r>
              <a:rPr lang="en-US" sz="1800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hl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800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+b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nd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B)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Nitrogen content (</a:t>
            </a:r>
            <a:r>
              <a:rPr lang="en-US" sz="1800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</a:t>
            </a:r>
            <a:r>
              <a:rPr lang="en-US" sz="1800" i="1" baseline="-250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ont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.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Each datapoint is the mean of four observations. Error bars indicate standard errors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pic>
        <p:nvPicPr>
          <p:cNvPr id="4" name="Picture 3" descr="Chart, bar chart&#10;&#10;Description automatically generated">
            <a:extLst>
              <a:ext uri="{FF2B5EF4-FFF2-40B4-BE49-F238E27FC236}">
                <a16:creationId xmlns:a16="http://schemas.microsoft.com/office/drawing/2014/main" id="{2079C56F-494F-44EF-8993-EFFE84F2AB5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39241" y="171520"/>
            <a:ext cx="4886220" cy="65149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351349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BD82547-908B-40BD-B05A-3A1B6796CFF7}"/>
              </a:ext>
            </a:extLst>
          </p:cNvPr>
          <p:cNvSpPr txBox="1"/>
          <p:nvPr/>
        </p:nvSpPr>
        <p:spPr>
          <a:xfrm>
            <a:off x="485010" y="5531094"/>
            <a:ext cx="110203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ure S4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: Correlation between measured parameters. Panel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, B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nd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C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show correlation for 22 July, 30 July and 11 Aug, respectively. The strength of the correlation can be guessed from the color</a:t>
            </a:r>
            <a:r>
              <a:rPr lang="ja-JP" alt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ar on the right where the positive and </a:t>
            </a:r>
            <a:r>
              <a:rPr lang="en-US" altLang="ja-JP" dirty="0">
                <a:latin typeface="Times New Roman" panose="02020603050405020304" pitchFamily="18" charset="0"/>
                <a:ea typeface="Times New Roman" panose="02020603050405020304" pitchFamily="18" charset="0"/>
              </a:rPr>
              <a:t>negative correlation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re shown with red and blue color, respectively. </a:t>
            </a:r>
            <a:endParaRPr lang="en-US" dirty="0"/>
          </a:p>
        </p:txBody>
      </p:sp>
      <p:pic>
        <p:nvPicPr>
          <p:cNvPr id="5" name="Picture 4" descr="A screenshot of a computer&#10;&#10;Description automatically generated with low confidence">
            <a:extLst>
              <a:ext uri="{FF2B5EF4-FFF2-40B4-BE49-F238E27FC236}">
                <a16:creationId xmlns:a16="http://schemas.microsoft.com/office/drawing/2014/main" id="{A3085476-D278-498B-B285-EDE3D721EDE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421203"/>
            <a:ext cx="12192000" cy="40155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31910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48</TotalTime>
  <Words>209</Words>
  <Application>Microsoft Office PowerPoint</Application>
  <PresentationFormat>Widescreen</PresentationFormat>
  <Paragraphs>4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Cambria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ammad Jan Shamim</dc:creator>
  <cp:lastModifiedBy>Mohammad Jan Shamim</cp:lastModifiedBy>
  <cp:revision>17</cp:revision>
  <dcterms:created xsi:type="dcterms:W3CDTF">2022-03-17T11:24:12Z</dcterms:created>
  <dcterms:modified xsi:type="dcterms:W3CDTF">2022-05-12T07:03:03Z</dcterms:modified>
</cp:coreProperties>
</file>